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7199313" cy="6840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0" autoAdjust="0"/>
    <p:restoredTop sz="94660"/>
  </p:normalViewPr>
  <p:slideViewPr>
    <p:cSldViewPr snapToGrid="0">
      <p:cViewPr varScale="1">
        <p:scale>
          <a:sx n="66" d="100"/>
          <a:sy n="66" d="100"/>
        </p:scale>
        <p:origin x="86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1119505"/>
            <a:ext cx="6119416" cy="2381521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3592866"/>
            <a:ext cx="5399485" cy="1651546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0840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3985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364195"/>
            <a:ext cx="1552352" cy="5797040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364195"/>
            <a:ext cx="4567064" cy="5797040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231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220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705386"/>
            <a:ext cx="6209407" cy="2845473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4577779"/>
            <a:ext cx="6209407" cy="149636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24047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820976"/>
            <a:ext cx="3059708" cy="434025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820976"/>
            <a:ext cx="3059708" cy="434025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980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364197"/>
            <a:ext cx="6209407" cy="1322188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676882"/>
            <a:ext cx="3045646" cy="82181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2498697"/>
            <a:ext cx="3045646" cy="367520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676882"/>
            <a:ext cx="3060646" cy="821814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2498697"/>
            <a:ext cx="3060646" cy="367520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7754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5778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5222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56036"/>
            <a:ext cx="2321966" cy="1596126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984912"/>
            <a:ext cx="3644652" cy="4861216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052161"/>
            <a:ext cx="2321966" cy="3801883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0563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456036"/>
            <a:ext cx="2321966" cy="1596126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984912"/>
            <a:ext cx="3644652" cy="4861216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2052161"/>
            <a:ext cx="2321966" cy="3801883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93693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364197"/>
            <a:ext cx="6209407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820976"/>
            <a:ext cx="6209407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6340167"/>
            <a:ext cx="1619845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0B8E6A-C2AD-42AD-8991-C710361AE6B5}" type="datetimeFigureOut">
              <a:rPr lang="de-DE" smtClean="0"/>
              <a:t>16.02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6340167"/>
            <a:ext cx="2429768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6340167"/>
            <a:ext cx="1619845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3174F-7B49-4F81-A340-4153646DE4F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9710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>
            <a:extLst>
              <a:ext uri="{FF2B5EF4-FFF2-40B4-BE49-F238E27FC236}">
                <a16:creationId xmlns:a16="http://schemas.microsoft.com/office/drawing/2014/main" id="{199C3F21-AABA-BD62-5415-8DEC4191449A}"/>
              </a:ext>
            </a:extLst>
          </p:cNvPr>
          <p:cNvSpPr txBox="1"/>
          <p:nvPr/>
        </p:nvSpPr>
        <p:spPr>
          <a:xfrm>
            <a:off x="252352" y="158063"/>
            <a:ext cx="6694607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S2: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verview of all gait parameters of Smartphone Group (SG) and Control Group (CG) including all measured data at Baseline (T0), Intermediate Examination (T1) and Post Test (T2).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aphicFrame>
        <p:nvGraphicFramePr>
          <p:cNvPr id="10" name="Tabelle 9">
            <a:extLst>
              <a:ext uri="{FF2B5EF4-FFF2-40B4-BE49-F238E27FC236}">
                <a16:creationId xmlns:a16="http://schemas.microsoft.com/office/drawing/2014/main" id="{48D01259-5A21-8E55-226E-F1B2A9DAE7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4832969"/>
              </p:ext>
            </p:extLst>
          </p:nvPr>
        </p:nvGraphicFramePr>
        <p:xfrm>
          <a:off x="300942" y="776439"/>
          <a:ext cx="6513746" cy="5816868"/>
        </p:xfrm>
        <a:graphic>
          <a:graphicData uri="http://schemas.openxmlformats.org/drawingml/2006/table">
            <a:tbl>
              <a:tblPr firstRow="1" firstCol="1" bandRow="1"/>
              <a:tblGrid>
                <a:gridCol w="764848">
                  <a:extLst>
                    <a:ext uri="{9D8B030D-6E8A-4147-A177-3AD203B41FA5}">
                      <a16:colId xmlns:a16="http://schemas.microsoft.com/office/drawing/2014/main" val="169119908"/>
                    </a:ext>
                  </a:extLst>
                </a:gridCol>
                <a:gridCol w="762816">
                  <a:extLst>
                    <a:ext uri="{9D8B030D-6E8A-4147-A177-3AD203B41FA5}">
                      <a16:colId xmlns:a16="http://schemas.microsoft.com/office/drawing/2014/main" val="4014524837"/>
                    </a:ext>
                  </a:extLst>
                </a:gridCol>
                <a:gridCol w="762816">
                  <a:extLst>
                    <a:ext uri="{9D8B030D-6E8A-4147-A177-3AD203B41FA5}">
                      <a16:colId xmlns:a16="http://schemas.microsoft.com/office/drawing/2014/main" val="2386843031"/>
                    </a:ext>
                  </a:extLst>
                </a:gridCol>
                <a:gridCol w="762816">
                  <a:extLst>
                    <a:ext uri="{9D8B030D-6E8A-4147-A177-3AD203B41FA5}">
                      <a16:colId xmlns:a16="http://schemas.microsoft.com/office/drawing/2014/main" val="162026184"/>
                    </a:ext>
                  </a:extLst>
                </a:gridCol>
                <a:gridCol w="762816">
                  <a:extLst>
                    <a:ext uri="{9D8B030D-6E8A-4147-A177-3AD203B41FA5}">
                      <a16:colId xmlns:a16="http://schemas.microsoft.com/office/drawing/2014/main" val="187250449"/>
                    </a:ext>
                  </a:extLst>
                </a:gridCol>
                <a:gridCol w="762816">
                  <a:extLst>
                    <a:ext uri="{9D8B030D-6E8A-4147-A177-3AD203B41FA5}">
                      <a16:colId xmlns:a16="http://schemas.microsoft.com/office/drawing/2014/main" val="2773164089"/>
                    </a:ext>
                  </a:extLst>
                </a:gridCol>
                <a:gridCol w="625970">
                  <a:extLst>
                    <a:ext uri="{9D8B030D-6E8A-4147-A177-3AD203B41FA5}">
                      <a16:colId xmlns:a16="http://schemas.microsoft.com/office/drawing/2014/main" val="3421067614"/>
                    </a:ext>
                  </a:extLst>
                </a:gridCol>
                <a:gridCol w="654424">
                  <a:extLst>
                    <a:ext uri="{9D8B030D-6E8A-4147-A177-3AD203B41FA5}">
                      <a16:colId xmlns:a16="http://schemas.microsoft.com/office/drawing/2014/main" val="320856709"/>
                    </a:ext>
                  </a:extLst>
                </a:gridCol>
                <a:gridCol w="654424">
                  <a:extLst>
                    <a:ext uri="{9D8B030D-6E8A-4147-A177-3AD203B41FA5}">
                      <a16:colId xmlns:a16="http://schemas.microsoft.com/office/drawing/2014/main" val="2137995585"/>
                    </a:ext>
                  </a:extLst>
                </a:gridCol>
              </a:tblGrid>
              <a:tr h="288910">
                <a:tc rowSpan="4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grid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</a:t>
                      </a:r>
                      <a:endParaRPr lang="de-DE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G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rowSpan="2"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l-GR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Δ T2 – T0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endParaRPr lang="it-IT" sz="9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 </a:t>
                      </a:r>
                      <a:r>
                        <a:rPr lang="it-IT" sz="900" b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value</a:t>
                      </a:r>
                      <a:endParaRPr lang="de-DE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4038894"/>
                  </a:ext>
                </a:extLst>
              </a:tr>
              <a:tr h="15711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800" dirty="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3722046"/>
                  </a:ext>
                </a:extLst>
              </a:tr>
              <a:tr h="514642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0 </a:t>
                      </a: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7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1 </a:t>
                      </a: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7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2 </a:t>
                      </a: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6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0 </a:t>
                      </a: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6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2 </a:t>
                      </a: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6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G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6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G</a:t>
                      </a:r>
                      <a:r>
                        <a:rPr lang="it-IT" sz="9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n=16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it-IT" sz="9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etween</a:t>
                      </a:r>
                      <a:r>
                        <a:rPr lang="it-IT" sz="9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groups)</a:t>
                      </a:r>
                      <a:endParaRPr lang="de-DE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6636809"/>
                  </a:ext>
                </a:extLst>
              </a:tr>
              <a:tr h="166891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an ± SD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an ± SD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an ± SD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an ± SD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an ± SD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8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de-DE" sz="800">
                        <a:effectLst/>
                        <a:latin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9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6857233"/>
                  </a:ext>
                </a:extLst>
              </a:tr>
              <a:tr h="188205">
                <a:tc gridSpan="9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ort steps and Bradyinesia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0791367"/>
                  </a:ext>
                </a:extLst>
              </a:tr>
              <a:tr h="2771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ride length (cm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 ± 0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 ± 0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 ± 0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 ± 0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4 ± 0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4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8471932"/>
                  </a:ext>
                </a:extLst>
              </a:tr>
              <a:tr h="41083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ait velocity (m/s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 ± 0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 ± 0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2 ± 0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 ± 0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3 ± 0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8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7869831"/>
                  </a:ext>
                </a:extLst>
              </a:tr>
              <a:tr h="2771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ride time (s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 ± 0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 ± 0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 ± 0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1 ± 0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 ± 0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04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0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9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65046618"/>
                  </a:ext>
                </a:extLst>
              </a:tr>
              <a:tr h="2771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ance time (%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4.7 ± 1.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3.9 ± 1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4.2 ± 1.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4.0 ± 1.5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3.6 ± 1.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4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40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0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0571908"/>
                  </a:ext>
                </a:extLst>
              </a:tr>
              <a:tr h="2771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wing time (%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.3 ± 1.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.1 ± 1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5.8 ± 1.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.0 ± 1.5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6.4 ± 1.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0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0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9994665"/>
                  </a:ext>
                </a:extLst>
              </a:tr>
              <a:tr h="188205">
                <a:tc gridSpan="9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huffling of gait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73349923"/>
                  </a:ext>
                </a:extLst>
              </a:tr>
              <a:tr h="27074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gle HS (°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1.6 ± 11.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1.8 ± 13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8.8 ± 16.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8.8 ± 13.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9.1 ± 10.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2.8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275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149661"/>
                  </a:ext>
                </a:extLst>
              </a:tr>
              <a:tr h="27074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gle TO (°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5.6 ± 8.0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.7 ± 5.9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8.9 ± 6.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2.9 ± 11.0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3.5 ± 9.0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2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9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3006324"/>
                  </a:ext>
                </a:extLst>
              </a:tr>
              <a:tr h="2771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ax. TC (cm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9 ± 1.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1 ± 1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6 ± 1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.1 ± 1.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.1 ± 3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29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9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25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2283693"/>
                  </a:ext>
                </a:extLst>
              </a:tr>
              <a:tr h="188205">
                <a:tc gridSpan="9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Regularity of gait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62241237"/>
                  </a:ext>
                </a:extLst>
              </a:tr>
              <a:tr h="2771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ride time CV (s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4 ± 6.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08 ± 4.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4 ± 3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5 ± 7.9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4 ± 4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99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2.05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72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963016"/>
                  </a:ext>
                </a:extLst>
              </a:tr>
              <a:tr h="27712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wing time CV (%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6 ± 4.0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41 ± 2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0 ± 2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4 ± 4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7 ± 1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6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7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9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5786930"/>
                  </a:ext>
                </a:extLst>
              </a:tr>
              <a:tr h="41083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ance time CV (%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6 ± 2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1 ± 1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8 ± 1.4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.6 ± 2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.7 ± 0.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8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0.8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9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0672438"/>
                  </a:ext>
                </a:extLst>
              </a:tr>
              <a:tr h="41083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tride length CV (cm)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3 ± 3.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9 ± 2.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.6 ± 1.7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.8 ± 4.8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.1 ± 1.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56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72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1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8177493"/>
                  </a:ext>
                </a:extLst>
              </a:tr>
              <a:tr h="41083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r>
                        <a:rPr lang="it-IT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ait velocity CV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.7 ± 3.3</a:t>
                      </a:r>
                      <a:endParaRPr lang="de-DE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9 ± 4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9 ± 4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.4 ± 5.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.5 ± 2.0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73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7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-1.91</a:t>
                      </a:r>
                      <a:endParaRPr lang="de-DE" sz="9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it-IT" sz="7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07</a:t>
                      </a:r>
                      <a:endParaRPr lang="de-DE" sz="9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1936" marR="3193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41233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83869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436</Words>
  <Application>Microsoft Office PowerPoint</Application>
  <PresentationFormat>Benutzerdefiniert</PresentationFormat>
  <Paragraphs>14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ützow, Lisa</dc:creator>
  <cp:lastModifiedBy>Lützow, Lisa</cp:lastModifiedBy>
  <cp:revision>3</cp:revision>
  <dcterms:created xsi:type="dcterms:W3CDTF">2023-02-16T07:37:04Z</dcterms:created>
  <dcterms:modified xsi:type="dcterms:W3CDTF">2023-02-16T07:45:20Z</dcterms:modified>
</cp:coreProperties>
</file>